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2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40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2DCD9F-E399-43C6-BA1D-1B67C220F3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8C7395B-3D3B-468B-A9AE-59B7298C75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CE050C-49E6-47D5-AEC6-85493E818B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CCAAC-A735-431C-94CC-E4B6DDBF524E}" type="datetimeFigureOut">
              <a:rPr lang="en-CA" smtClean="0"/>
              <a:t>2018-09-29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A69839-E4A9-409A-81D8-FAE18AB956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489B9F-D5BA-4ACE-BE9A-1ABED25E7F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5B7E3-65C7-46D0-9175-CCAB49FEC37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73298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3E99F5-44AE-4FFF-A088-BFDCFB12A1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4E7F30B-F7DB-4843-9DE6-02061AE85C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73C3D5-21F1-4F04-B450-D4AA041D9F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CCAAC-A735-431C-94CC-E4B6DDBF524E}" type="datetimeFigureOut">
              <a:rPr lang="en-CA" smtClean="0"/>
              <a:t>2018-09-29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FCF172-179C-469F-94B9-63D24E70B5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6F153E-92E4-4434-862E-ABE229AB9A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5B7E3-65C7-46D0-9175-CCAB49FEC37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910181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DCC75E0-6C28-4A76-8413-6715DFF856F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996415-29C3-43B1-A28A-7B76C55968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302E5E-E1FA-48F5-9271-AA0974195A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CCAAC-A735-431C-94CC-E4B6DDBF524E}" type="datetimeFigureOut">
              <a:rPr lang="en-CA" smtClean="0"/>
              <a:t>2018-09-29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3C1D44-C3ED-4DCB-9C3D-4269D8B2F3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53FF68-CDBB-4448-AB3D-C90161E44A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5B7E3-65C7-46D0-9175-CCAB49FEC37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49025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235B4A-E40C-4AB4-BD39-A028295946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0F1C7C-BDE5-4016-AFBE-95AF66ED83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5703AE-30BD-4C4B-BED6-062FDB9F9A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CCAAC-A735-431C-94CC-E4B6DDBF524E}" type="datetimeFigureOut">
              <a:rPr lang="en-CA" smtClean="0"/>
              <a:t>2018-09-29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9B5C53-FBE0-499A-9CA8-6C7DDCCDAA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5DC20D-8ACC-4D8C-8E50-105CE99D25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5B7E3-65C7-46D0-9175-CCAB49FEC37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62328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054FA3-96BA-4C75-A020-60B29F17F7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A9CFE6-1F10-41B5-A8BC-1DD45B6890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CEAA42-361D-4302-AD74-808F849AC8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CCAAC-A735-431C-94CC-E4B6DDBF524E}" type="datetimeFigureOut">
              <a:rPr lang="en-CA" smtClean="0"/>
              <a:t>2018-09-29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CADBAA-535A-434A-BEB3-528BCF90C3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789CC4-4540-46CF-8387-E311D6F774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5B7E3-65C7-46D0-9175-CCAB49FEC37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971738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1FB921-EA48-4272-9A65-957F5CC6A0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9A0956-7E22-4929-A5DF-B547A0E715F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CDD1611-2BB7-46EF-9A84-34DC301CD9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D733B6-FFF5-4812-AA6A-45B251ACFD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CCAAC-A735-431C-94CC-E4B6DDBF524E}" type="datetimeFigureOut">
              <a:rPr lang="en-CA" smtClean="0"/>
              <a:t>2018-09-29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65FA86-EE8A-4E32-9A92-2AC6C90A06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80530C-9E32-46E4-A41F-CB92FBDA4C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5B7E3-65C7-46D0-9175-CCAB49FEC37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48671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9E5F5F-544B-412D-B96A-F3A8D69C04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FCEAF7-57B1-44FD-B1D5-4509D3D268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54141DB-C9CB-472B-85C7-C028BF8E1F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D2A4126-6C99-44F2-9B0F-A84C9380ED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730F4D3-18B1-43DA-A921-F91EDB7778C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4344E1D-5C4A-4251-9FD1-F1C41C83A3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CCAAC-A735-431C-94CC-E4B6DDBF524E}" type="datetimeFigureOut">
              <a:rPr lang="en-CA" smtClean="0"/>
              <a:t>2018-09-29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435506E-6F19-4799-A195-0BF68EA96F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79CB022-3D98-4E76-BE69-605245F7A3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5B7E3-65C7-46D0-9175-CCAB49FEC37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202511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61E84-B165-49DB-93AC-4F6D07858B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4D859A8-2B33-4881-8EDB-DC28819C1C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CCAAC-A735-431C-94CC-E4B6DDBF524E}" type="datetimeFigureOut">
              <a:rPr lang="en-CA" smtClean="0"/>
              <a:t>2018-09-29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8411C36-E9CE-4513-9025-143B7ACDCC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C969655-C531-42DB-9005-0B75DE0231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5B7E3-65C7-46D0-9175-CCAB49FEC37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970809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AD4DFB0-79CF-4BEB-A80A-AE512C3BC3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CCAAC-A735-431C-94CC-E4B6DDBF524E}" type="datetimeFigureOut">
              <a:rPr lang="en-CA" smtClean="0"/>
              <a:t>2018-09-29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0CFD121-45E1-412E-9394-DEE264FDE0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12E5489-DBD0-4EB8-8082-33EF502168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5B7E3-65C7-46D0-9175-CCAB49FEC37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434420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2C14D3-8753-4DE4-85D7-41F4A093C2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52403F-114A-452F-A3F6-473004ACCE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14FDC39-AB50-42C9-9294-83C40E8494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8F9296-3F4D-4975-A361-B0F9E20F8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CCAAC-A735-431C-94CC-E4B6DDBF524E}" type="datetimeFigureOut">
              <a:rPr lang="en-CA" smtClean="0"/>
              <a:t>2018-09-29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F2078A-87A6-4AE1-BC4C-529F9E6F1B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58D63B-8292-4615-875B-D9494F3895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5B7E3-65C7-46D0-9175-CCAB49FEC37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47639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45A125-6B5D-4998-B616-3B1CDABA90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1399C69-FB9C-42FB-9C53-B466F4885D3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37E647-CC84-4D49-8557-D35241F0E9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5EB2DA-D476-40AB-9008-4165D07F8F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CCAAC-A735-431C-94CC-E4B6DDBF524E}" type="datetimeFigureOut">
              <a:rPr lang="en-CA" smtClean="0"/>
              <a:t>2018-09-29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AFCFEF8-98AE-46FB-9FA0-D5B40E6EC9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079396-13B8-41B9-B0B0-E13F7F4273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5B7E3-65C7-46D0-9175-CCAB49FEC37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356428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802DF3F-6964-4AFE-B512-93E8322E1C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EDB606-5B1C-4F57-BB29-098BB9599E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C6CEA1-9B79-4A1B-AAC2-01ACF969C08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ACCAAC-A735-431C-94CC-E4B6DDBF524E}" type="datetimeFigureOut">
              <a:rPr lang="en-CA" smtClean="0"/>
              <a:t>2018-09-29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E59198-D203-44FC-A4D5-5E60D144E1C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DF102D-E290-4886-BB7E-364A86998C7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65B7E3-65C7-46D0-9175-CCAB49FEC37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597184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1748D97F-1F9D-4006-8B37-16757057077F}"/>
              </a:ext>
            </a:extLst>
          </p:cNvPr>
          <p:cNvGrpSpPr/>
          <p:nvPr/>
        </p:nvGrpSpPr>
        <p:grpSpPr>
          <a:xfrm>
            <a:off x="934066" y="375042"/>
            <a:ext cx="10680819" cy="5401071"/>
            <a:chOff x="214509" y="1365229"/>
            <a:chExt cx="10680819" cy="5401071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0B2473F2-8919-44F6-8165-1B286F20AA4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4509" y="4114053"/>
              <a:ext cx="2629181" cy="2551953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C563B9B7-4FAE-4F69-B877-B8361D1E67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661" b="40025"/>
            <a:stretch/>
          </p:blipFill>
          <p:spPr>
            <a:xfrm>
              <a:off x="823141" y="4467130"/>
              <a:ext cx="1838223" cy="332759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00771B50-578F-4BAB-9940-49728EEF2B1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843690" y="4155374"/>
              <a:ext cx="2629264" cy="2610926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2C63556E-7E1E-4D52-B742-F990964E5E5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5736" r="1523" b="30388"/>
            <a:stretch/>
          </p:blipFill>
          <p:spPr>
            <a:xfrm>
              <a:off x="3402061" y="4497788"/>
              <a:ext cx="1813568" cy="34137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A23EA23F-84A9-4459-87F2-389A2595855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442351" y="4017476"/>
              <a:ext cx="2747472" cy="2748824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18348A4F-0B64-4B60-A535-EB70E31A7F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-1" t="3343" r="1734" b="31454"/>
            <a:stretch/>
          </p:blipFill>
          <p:spPr>
            <a:xfrm>
              <a:off x="6031324" y="4447348"/>
              <a:ext cx="1983627" cy="373856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DF6F3977-34E3-4230-B91D-7417D20BBE9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8189823" y="4155374"/>
              <a:ext cx="2671287" cy="2610926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521FF0AE-4C32-49CC-ACC4-50D2633E6B9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r="2321" b="37168"/>
            <a:stretch/>
          </p:blipFill>
          <p:spPr>
            <a:xfrm>
              <a:off x="8748193" y="4424487"/>
              <a:ext cx="1971775" cy="375402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E9DE4264-2173-4F91-8297-24B26D340E2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14509" y="1383287"/>
              <a:ext cx="2629181" cy="2630474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727B75B8-FC32-4E07-A1AE-E9F1CEF1F2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t="3352" b="29989"/>
            <a:stretch/>
          </p:blipFill>
          <p:spPr>
            <a:xfrm>
              <a:off x="586216" y="1742661"/>
              <a:ext cx="2075149" cy="398770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93412A1E-0FA4-4BF2-8052-6B783F2E4608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843690" y="1383286"/>
              <a:ext cx="2739802" cy="2730767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310AB015-3E22-4A7B-B6B2-71EC7FEFBC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t="-18945" b="36724"/>
            <a:stretch/>
          </p:blipFill>
          <p:spPr>
            <a:xfrm>
              <a:off x="3402060" y="1611777"/>
              <a:ext cx="1967083" cy="481028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DAF2B16A-005C-4D73-BE82-AC2707BFF759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5583492" y="1365229"/>
              <a:ext cx="2687956" cy="2648532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FF7F58C3-BFC4-4AD5-9398-3828C939BA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r="554" b="28336"/>
            <a:stretch/>
          </p:blipFill>
          <p:spPr>
            <a:xfrm>
              <a:off x="5991581" y="1700103"/>
              <a:ext cx="2073294" cy="392702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D0FA176B-38C9-490D-904E-F2DD2FC3728D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8223050" y="1440460"/>
              <a:ext cx="2672278" cy="2673593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A61F27C3-4857-404C-8433-CF106EF19A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/>
            <a:srcRect t="1690" b="30373"/>
            <a:stretch/>
          </p:blipFill>
          <p:spPr>
            <a:xfrm>
              <a:off x="8581452" y="1671099"/>
              <a:ext cx="2185372" cy="421706"/>
            </a:xfrm>
            <a:prstGeom prst="rect">
              <a:avLst/>
            </a:prstGeom>
          </p:spPr>
        </p:pic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827E43C9-5981-409E-BAE6-40542D892B18}"/>
              </a:ext>
            </a:extLst>
          </p:cNvPr>
          <p:cNvSpPr txBox="1"/>
          <p:nvPr/>
        </p:nvSpPr>
        <p:spPr>
          <a:xfrm>
            <a:off x="1472631" y="5874194"/>
            <a:ext cx="966083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400" dirty="0"/>
              <a:t>Bacteriophage P1 (100 kbp DNA genome) FCM detection attempt.  </a:t>
            </a:r>
          </a:p>
          <a:p>
            <a:r>
              <a:rPr lang="en-CA" sz="2400" dirty="0"/>
              <a:t>P1 – SYBR Green I signal population; P2 – expected virus zone</a:t>
            </a:r>
          </a:p>
        </p:txBody>
      </p:sp>
    </p:spTree>
    <p:extLst>
      <p:ext uri="{BB962C8B-B14F-4D97-AF65-F5344CB8AC3E}">
        <p14:creationId xmlns:p14="http://schemas.microsoft.com/office/powerpoint/2010/main" val="40616289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8</TotalTime>
  <Words>25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ena</dc:creator>
  <cp:lastModifiedBy>Nicholas Ashbolt</cp:lastModifiedBy>
  <cp:revision>11</cp:revision>
  <dcterms:created xsi:type="dcterms:W3CDTF">2018-09-17T23:55:12Z</dcterms:created>
  <dcterms:modified xsi:type="dcterms:W3CDTF">2018-09-29T13:00:53Z</dcterms:modified>
</cp:coreProperties>
</file>